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10" autoAdjust="0"/>
  </p:normalViewPr>
  <p:slideViewPr>
    <p:cSldViewPr snapToGrid="0">
      <p:cViewPr varScale="1">
        <p:scale>
          <a:sx n="79" d="100"/>
          <a:sy n="79" d="100"/>
        </p:scale>
        <p:origin x="82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1949D-77EF-5C44-B6F4-19FAF48F7D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1C999C-D7C8-651D-51F6-1996FB4F96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29E3E7-C3B0-EAEE-5ECC-EE075E60A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34E4C0-1731-E85D-A305-DA8E2E206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167779-7D6C-B826-C5AE-2776A86B0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758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8F842-249E-1879-350B-666709039F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F4B60F-3860-AE5A-A2B7-2D30467DC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2142E-6F1C-38ED-0956-AF2EBFA0C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69A67-6B6F-F9F5-BAC7-72A4695EB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EE94B-6099-952B-B1E1-FA6A058D8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394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4112E1-71BC-5411-057C-613A25A00B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4A63D1-E960-B40F-F6B4-9C74196DF1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8F607-B01B-3760-4614-F994F0762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128BDC-4FF0-6248-8B83-E8510228C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3F64AD-AB25-6F7C-4EBE-84822A6BC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84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D65A8-B600-377F-2ED9-17855D350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DE9406-8393-2404-BE89-EF62BD662F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BEB1DF-7200-06D1-F814-E197B1F53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B1CC01-E216-15F8-4BCF-C4E556A9C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5AC372-79AD-0C5A-7AEA-C0FE64881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675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DFD85-AD13-9426-6F0F-1DD4CC73B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4D707D-F151-F363-837F-2D703E3F7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C32900-9230-941F-D1D2-FD80D10F9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8B0D8-F11B-4C40-0BF6-8DF2B483C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64159A-3CF0-04C4-080D-2108A9DC5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632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C001F-99A4-2403-1C2C-B5FAA4030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F205E2-2AD4-4842-1DE8-5D668207DD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3C72CE-4C29-E7D4-5BA0-4EE18C1D26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83D631-7174-7907-A771-2A383A55C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1DE8CF-BBF3-EB31-36A2-28298B13B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744B4C-1DB5-8332-9577-EC3281B34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295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8340F-E107-DCDA-6FA5-1952218D8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C2BB82-4760-BBC4-5042-B69B0D01A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CF37D-519D-E242-1C20-0CCD0F81A2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739002-85D5-5207-5846-236ED6DB05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21051FF-A64D-AEFD-F3C7-6CD0C79586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F8C78A-236B-00F0-3EFD-B5EEB9516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681862-245A-5CAC-07B6-0DB082745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08E98A-DB40-6DD9-51A1-1001D740E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62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1BD5E-1716-0E73-752F-390766F96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5798459-52AB-9DB7-6376-ED6542858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E019C6F-25C6-CDC9-9919-D680314DC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8690A9-9924-CE3F-2877-90AA0C9CC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080DE2-B39F-8B69-3026-B354880EF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1F334C-B287-1802-572F-EEF7ACC2E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C8D9B91-8A2B-E276-C85E-27956F0E5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864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9B647-DAD9-398E-6FDD-294A269AEF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A20127-64F6-AE79-4D95-99B79C5FE0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36BECE-5FDE-8265-8DF8-2D6B40874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D2E1F-4A07-CF28-C274-FA95939A5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2D64A1-4EFD-215D-9374-3D3D05CD7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BFD3CE-1297-54B1-72CE-DC8606C68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83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42388-D15A-A900-46A8-84EEFAC3C6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8BF48B-5CF6-FAAD-8836-A4AFF6F47C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E2676B-06B1-E0C3-5A84-D86F43022B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FCFA7E-9108-E51E-B778-2E5070506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9E9FC-8658-3CCC-6A41-A423397DC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6540D4-45D0-2A8D-1D0D-0B24EA23A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817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F4028F-4D81-D193-AC51-E4C8D3417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B7B880-F8F2-E8FF-AB63-2970D44D8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228EF3-6604-1DA2-B203-940CB75332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56E15A-A133-48A3-AFE4-B4D512D779A2}" type="datetimeFigureOut">
              <a:rPr lang="en-US" smtClean="0"/>
              <a:t>7/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BE50F5-3C2E-CD04-95AA-FD1A1A9119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6529A9-B58F-E8C1-4FED-05E27F01FE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A56213-9F08-4B77-8E56-C21A7E1248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691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804E5C2-DA2A-648E-F2D9-68605CF08C97}"/>
              </a:ext>
            </a:extLst>
          </p:cNvPr>
          <p:cNvGrpSpPr/>
          <p:nvPr/>
        </p:nvGrpSpPr>
        <p:grpSpPr>
          <a:xfrm>
            <a:off x="5418969" y="271877"/>
            <a:ext cx="6209750" cy="2704069"/>
            <a:chOff x="12590128" y="8335407"/>
            <a:chExt cx="8623825" cy="324219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077443F-3264-FD04-A83E-C4B6F3AC35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047089" y="8340545"/>
              <a:ext cx="8166864" cy="323706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B1B6931-BC11-2BFC-911B-77C668F34ED0}"/>
                </a:ext>
              </a:extLst>
            </p:cNvPr>
            <p:cNvSpPr txBox="1"/>
            <p:nvPr/>
          </p:nvSpPr>
          <p:spPr>
            <a:xfrm>
              <a:off x="12590128" y="8335407"/>
              <a:ext cx="434550" cy="4797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8462C7F5-B492-C3BC-9CE1-52446A6B1845}"/>
              </a:ext>
            </a:extLst>
          </p:cNvPr>
          <p:cNvGrpSpPr/>
          <p:nvPr/>
        </p:nvGrpSpPr>
        <p:grpSpPr>
          <a:xfrm>
            <a:off x="5419685" y="3123352"/>
            <a:ext cx="6209034" cy="2714453"/>
            <a:chOff x="12540701" y="11617960"/>
            <a:chExt cx="8661645" cy="381055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C3FF2D8-A298-414E-3F35-7C281B43D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98719" y="11629661"/>
              <a:ext cx="8203627" cy="379885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E245CC6-C2E4-CC0C-D320-DC8B43D4CD62}"/>
                </a:ext>
              </a:extLst>
            </p:cNvPr>
            <p:cNvSpPr txBox="1"/>
            <p:nvPr/>
          </p:nvSpPr>
          <p:spPr>
            <a:xfrm>
              <a:off x="12540701" y="11617960"/>
              <a:ext cx="436506" cy="5616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C4A5A73D-54E8-1FE1-3BDB-5802ADC5918C}"/>
              </a:ext>
            </a:extLst>
          </p:cNvPr>
          <p:cNvGrpSpPr/>
          <p:nvPr/>
        </p:nvGrpSpPr>
        <p:grpSpPr>
          <a:xfrm>
            <a:off x="734731" y="271877"/>
            <a:ext cx="4468865" cy="4008647"/>
            <a:chOff x="21075160" y="8124980"/>
            <a:chExt cx="7931356" cy="730354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94F37BB-362C-0D66-0B9A-925B2192596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591654" y="8124982"/>
              <a:ext cx="7414862" cy="730353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B92ED13-8D85-7C2A-4596-49437956A392}"/>
                </a:ext>
              </a:extLst>
            </p:cNvPr>
            <p:cNvSpPr txBox="1"/>
            <p:nvPr/>
          </p:nvSpPr>
          <p:spPr>
            <a:xfrm>
              <a:off x="21075160" y="8124980"/>
              <a:ext cx="515224" cy="7289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FFC9F857-2B2F-9FB6-C805-3C3A2CE1C02A}"/>
              </a:ext>
            </a:extLst>
          </p:cNvPr>
          <p:cNvSpPr txBox="1"/>
          <p:nvPr/>
        </p:nvSpPr>
        <p:spPr>
          <a:xfrm>
            <a:off x="2559050" y="6135562"/>
            <a:ext cx="75374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/>
              <a:t>Table S1</a:t>
            </a:r>
            <a:r>
              <a:rPr lang="en-US" sz="900" dirty="0"/>
              <a:t>: Ginsenoside content in non-saponin (0 mg/g) and saponin fractions (average 167.01 mg/g for 3 types, 382.65 mg/g for 11 types) via HPLC.</a:t>
            </a:r>
          </a:p>
          <a:p>
            <a:r>
              <a:rPr lang="en-US" sz="900" b="1" dirty="0"/>
              <a:t>Table S2</a:t>
            </a:r>
            <a:r>
              <a:rPr lang="en-US" sz="900" dirty="0"/>
              <a:t>: Red ginseng polysaccharides in non-saponin (average 94.23 mg/g) and saponin fractions (average 5.57 mg/g) using the carbazole method.</a:t>
            </a:r>
          </a:p>
          <a:p>
            <a:r>
              <a:rPr lang="en-US" sz="900" b="1"/>
              <a:t>Table S3</a:t>
            </a:r>
            <a:r>
              <a:rPr lang="en-US" sz="900" dirty="0"/>
              <a:t>: Red ginseng polysaccharides composition (galacturonic acid, galactose, arabinose) in non-saponin (56.20 mg/g) and saponin fractions (32.90 mg/g) via HPLC.</a:t>
            </a:r>
          </a:p>
        </p:txBody>
      </p:sp>
    </p:spTree>
    <p:extLst>
      <p:ext uri="{BB962C8B-B14F-4D97-AF65-F5344CB8AC3E}">
        <p14:creationId xmlns:p14="http://schemas.microsoft.com/office/powerpoint/2010/main" val="4180486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105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odir Rustamov</dc:creator>
  <cp:lastModifiedBy>MDPI</cp:lastModifiedBy>
  <cp:revision>3</cp:revision>
  <dcterms:created xsi:type="dcterms:W3CDTF">2024-06-13T03:42:33Z</dcterms:created>
  <dcterms:modified xsi:type="dcterms:W3CDTF">2024-07-04T03:10:51Z</dcterms:modified>
</cp:coreProperties>
</file>